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61" r:id="rId3"/>
    <p:sldId id="259" r:id="rId4"/>
    <p:sldId id="262" r:id="rId5"/>
    <p:sldId id="260" r:id="rId6"/>
    <p:sldId id="263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indows User" initials="WU" lastIdx="1" clrIdx="0">
    <p:extLst>
      <p:ext uri="{19B8F6BF-5375-455C-9EA6-DF929625EA0E}">
        <p15:presenceInfo xmlns:p15="http://schemas.microsoft.com/office/powerpoint/2012/main" userId="ccae270cf01d69f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75657" autoAdjust="0"/>
  </p:normalViewPr>
  <p:slideViewPr>
    <p:cSldViewPr snapToGrid="0">
      <p:cViewPr varScale="1">
        <p:scale>
          <a:sx n="61" d="100"/>
          <a:sy n="61" d="100"/>
        </p:scale>
        <p:origin x="146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C30F45-0836-475E-9303-8C7E6E6955E3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8E61C8-A5C2-4550-84D4-C5A79AA152F0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7017301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8492106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2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542186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3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63545181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4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6720889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5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8135751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E61C8-A5C2-4550-84D4-C5A79AA152F0}" type="slidenum">
              <a:rPr lang="es-ES_tradnl" smtClean="0"/>
              <a:t>6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9295951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C3E4914-78AA-4A04-87F4-0AE7D67915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B6B8D36-9CB5-49D8-AA78-A1EB74128B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22BE74-3389-4580-A68F-4C9DC84E3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D66FB9-C404-4C58-A22E-EE1D5B7350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B0B9AF6-636D-4963-99B9-81FE0CCF7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5864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8925AC-6D7E-40A2-836A-2112999C5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FE3F3F3-3D7C-4516-93B3-EC2CDCE415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219FBC1-776A-470C-8101-74CE2833B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762ADF-CE85-40DD-8113-CAEFF2630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3723945-1F93-4E88-83E0-10113ED07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51300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3B1C02F-40A9-4C70-8902-1A9DFE1763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08BE10E-9C14-41CF-8C5A-A837C9197A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1029DC-E57A-4AF3-ACC1-748AA00E6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365E3E8-5A5C-4A6C-BFFC-BDE6A96096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99F5CF0-FFCF-4EB7-8EA8-088F833A7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95990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2C178A-C4BB-4B84-9FF9-406DD4345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D7E64D9E-85E9-45B0-BF39-732800633A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547E5E9-FBBB-4EF4-BC36-0DABCF61A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8110F1F-0E59-4EB9-B041-F96CBA2402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83AC83E-C3B3-439B-843C-78D5CC18F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033355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030604-55C0-404E-9F00-937192D02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73C6E09-E6D9-405F-BC4F-01993FB451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AA87031-46E9-410B-A405-DE5D7EE7D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0C667D5-DC4F-4F88-9F42-562A98389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0AFC128-A99F-4C2D-A4C1-B03E2496E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999775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143994-D16B-423E-BE0B-98E674C1E2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41C6F69-3137-4506-A792-69F66DB2D7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350CDDC-EA93-4023-891C-E2CAF4E82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388DC8-AD8B-4EB8-8AB1-48B13A5E5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BBCC5EE-60BD-4ADA-A7A8-493AD923D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1240FEB-E36E-481F-86E0-C9761E8AC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10427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813EB93-6B91-4D38-A193-9791661D9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04EE65B-232D-49EA-8306-A4D0F99A00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4EB5AB4-B883-4E19-B6E6-21F97326C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B5BD175-608E-439B-97B2-5B31BA672B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291244DA-64ED-430C-912F-153C32AC90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0B2B7F0-F2C0-47DF-A92B-E9004036C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1C59E1C-5BEA-4DEB-A397-920754E93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C50270F-FF52-4751-A2AF-E5CDDEE84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48439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96A63D7-8EBE-4B90-AA55-E8E567394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71C9475-CCF3-4B62-A678-045A34570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49D96A20-B826-4016-A341-0B5F4EA92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6864EE0-7DF8-46FF-8F6F-5C07E1E46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350852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BCBFF731-69E4-4DE4-A429-1DE563B75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3CA0656-7580-4F7D-9FAE-C7BCF4D4D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8353760-50D5-40CF-832C-BB645CCCC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71974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BC2DE30-E2DD-4F0A-92B6-39FE78C26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4068343-0F82-4656-A0B2-42CE7B3C69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97B682A6-3AFA-4CF9-8A38-F65B4F9024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876872-EB30-4CBC-AAB5-0DE8D1684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18EBB06-3A3D-41CC-9210-98AFB42D5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B6FD056-E10A-4BCE-BB13-029104962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105955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F129E17-B372-45F7-A4AF-5E6F887C0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DC10BC79-4909-485D-BE08-952988283DE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806F9E2-C349-4DE6-A0FA-4169406E9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A7EE29A2-60D5-4393-9867-E4AA604FC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6D23851-961E-4594-8527-0998448E5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9486B52-E684-4067-810B-5EB330447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18591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8E80821-124B-4404-B334-03893DB37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ES_tradn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C08CB28-769C-429D-86E4-485DEF410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5A42A4F-316D-445F-879D-18B47EDC3B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1823D-F14F-41EA-9C1B-6F2EEFF5788D}" type="datetimeFigureOut">
              <a:rPr lang="es-ES_tradnl" smtClean="0"/>
              <a:t>20/05/2024</a:t>
            </a:fld>
            <a:endParaRPr lang="es-ES_tradn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62F7703-3105-406C-B6D5-969DF17CBC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776FE2E-A4EE-4D10-918A-7297E112DC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857839-F978-410F-9854-E9D913D4F478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36442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06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a) GSE36389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810987AE-82D9-41D8-A8D7-8F8C1E2309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099" y="1632357"/>
            <a:ext cx="5771260" cy="4265923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DD825570-56A7-48C7-A88B-6195B33D99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44481" y="1632357"/>
            <a:ext cx="5394036" cy="4315229"/>
          </a:xfrm>
          <a:prstGeom prst="rect">
            <a:avLst/>
          </a:prstGeom>
        </p:spPr>
      </p:pic>
      <p:sp>
        <p:nvSpPr>
          <p:cNvPr id="2" name="Rectángulo 1">
            <a:extLst>
              <a:ext uri="{FF2B5EF4-FFF2-40B4-BE49-F238E27FC236}">
                <a16:creationId xmlns:a16="http://schemas.microsoft.com/office/drawing/2014/main" id="{B5846306-3901-4236-8AF7-85CAAC2A0C86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414411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780576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b) GSE63678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972134" y="370277"/>
            <a:ext cx="22477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al </a:t>
            </a:r>
            <a:r>
              <a:rPr lang="es-ES_tradnl" sz="2000" b="1" dirty="0" err="1"/>
              <a:t>cancer</a:t>
            </a:r>
            <a:endParaRPr lang="es-ES_tradnl" sz="2000" b="1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4CB89D43-6A7E-477C-BBDD-99DECA0421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519" y="1757617"/>
            <a:ext cx="5740148" cy="4242926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F39A1EF0-A6FA-4E8B-B44C-CAF220B63D1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904" y="1757617"/>
            <a:ext cx="5303658" cy="4242926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059C064C-7930-4A6E-8A0B-A751B2C090A0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861808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47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c) GSE7846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D23BF700-CA72-4FA6-B18C-A20138FC35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692" y="1618926"/>
            <a:ext cx="6002308" cy="4436706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018BEBAA-C59A-4919-AC90-DBBCAAB22D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91304" y="1632758"/>
            <a:ext cx="5507004" cy="4405603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3F7DD751-0BF6-41B5-B520-0741D0B4720D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8192837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1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d) GSE1750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5242723" y="370277"/>
            <a:ext cx="17073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/>
              <a:t>Endometriosis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BD8AAC98-DBBE-4034-9B02-BF1E081310A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010" y="1747318"/>
            <a:ext cx="5722925" cy="4230195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DF7CE135-D2FD-40A2-95E5-56F41C9D201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8082" y="1705331"/>
            <a:ext cx="5397908" cy="4318327"/>
          </a:xfrm>
          <a:prstGeom prst="rect">
            <a:avLst/>
          </a:prstGeom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FE7A3F29-36B3-4E74-9119-97798DD59852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2555973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608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e) GSE12814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78A0FFD7-487D-4E90-AF40-71849D09C94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226" y="1760904"/>
            <a:ext cx="5647540" cy="4179180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E12B1A94-530B-404A-868D-06E64C8966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7064" y="1568694"/>
            <a:ext cx="5610030" cy="4488024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31E5491F-63DE-4185-BCE2-896DAA942691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3641791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>
            <a:extLst>
              <a:ext uri="{FF2B5EF4-FFF2-40B4-BE49-F238E27FC236}">
                <a16:creationId xmlns:a16="http://schemas.microsoft.com/office/drawing/2014/main" id="{6C66FDA2-E512-44BA-B4AC-29172E1E3A9B}"/>
              </a:ext>
            </a:extLst>
          </p:cNvPr>
          <p:cNvSpPr txBox="1"/>
          <p:nvPr/>
        </p:nvSpPr>
        <p:spPr>
          <a:xfrm>
            <a:off x="1823953" y="1026367"/>
            <a:ext cx="2569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b="1" dirty="0"/>
              <a:t>f) GSE23112 GEO </a:t>
            </a:r>
            <a:r>
              <a:rPr lang="es-ES_tradnl" b="1" dirty="0" err="1"/>
              <a:t>dataset</a:t>
            </a:r>
            <a:endParaRPr lang="es-ES_tradnl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9A524518-BEF5-4D0A-A52D-276C3B94F293}"/>
              </a:ext>
            </a:extLst>
          </p:cNvPr>
          <p:cNvSpPr txBox="1"/>
          <p:nvPr/>
        </p:nvSpPr>
        <p:spPr>
          <a:xfrm>
            <a:off x="4888164" y="370277"/>
            <a:ext cx="23366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000" b="1" dirty="0" err="1"/>
              <a:t>Uterine</a:t>
            </a:r>
            <a:r>
              <a:rPr lang="es-ES_tradnl" sz="2000" b="1" dirty="0"/>
              <a:t> </a:t>
            </a:r>
            <a:r>
              <a:rPr lang="es-ES_tradnl" sz="2000" b="1" dirty="0" err="1"/>
              <a:t>leiomyomas</a:t>
            </a:r>
            <a:endParaRPr lang="es-ES_tradnl" sz="2000" b="1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38106C4F-485E-49F7-902A-9A50EEB8F5B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187" y="1795926"/>
            <a:ext cx="5617125" cy="4151991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7E15751F-2CA8-4B8D-A2D8-DD26B5699D0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4775" y="1643084"/>
            <a:ext cx="5381042" cy="4304833"/>
          </a:xfrm>
          <a:prstGeom prst="rect">
            <a:avLst/>
          </a:prstGeom>
        </p:spPr>
      </p:pic>
      <p:sp>
        <p:nvSpPr>
          <p:cNvPr id="6" name="Rectángulo 5">
            <a:extLst>
              <a:ext uri="{FF2B5EF4-FFF2-40B4-BE49-F238E27FC236}">
                <a16:creationId xmlns:a16="http://schemas.microsoft.com/office/drawing/2014/main" id="{E08690F7-E728-48DE-9117-DA50B7B016CB}"/>
              </a:ext>
            </a:extLst>
          </p:cNvPr>
          <p:cNvSpPr/>
          <p:nvPr/>
        </p:nvSpPr>
        <p:spPr>
          <a:xfrm>
            <a:off x="236099" y="6226113"/>
            <a:ext cx="11685034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de-by-side volcano plots with the x-axis representing log2 fold change and the y-axis representing -log10 p-value showing the relationship between the statistics of Empirical Bayes (left) and CASh 0.05 (right) p-values. </a:t>
            </a:r>
            <a:endParaRPr lang="es-ES_tradnl" sz="1400" dirty="0"/>
          </a:p>
        </p:txBody>
      </p:sp>
    </p:spTree>
    <p:extLst>
      <p:ext uri="{BB962C8B-B14F-4D97-AF65-F5344CB8AC3E}">
        <p14:creationId xmlns:p14="http://schemas.microsoft.com/office/powerpoint/2010/main" val="179957988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1</TotalTime>
  <Words>268</Words>
  <Application>Microsoft Office PowerPoint</Application>
  <PresentationFormat>Panorámica</PresentationFormat>
  <Paragraphs>24</Paragraphs>
  <Slides>6</Slides>
  <Notes>6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 User</dc:creator>
  <cp:lastModifiedBy>Windows User</cp:lastModifiedBy>
  <cp:revision>27</cp:revision>
  <dcterms:created xsi:type="dcterms:W3CDTF">2024-05-16T14:56:22Z</dcterms:created>
  <dcterms:modified xsi:type="dcterms:W3CDTF">2024-05-20T19:39:51Z</dcterms:modified>
</cp:coreProperties>
</file>